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EDEEF-CDE5-4983-A39B-26CD523DE5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B5B18-FFE6-4481-AB66-9015C59A86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C5B16-B415-47D0-8914-644313BD90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2EE91-0A65-4BDE-8618-60E0A415B7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C081A-1758-4A1F-9A44-411E5A165D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53583-E0BD-4D30-B6C7-8FD0C13111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9C639-1F9A-4E03-A323-254748BEED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A4D78-DE60-4BF8-A4C9-76FBC8BF5B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23396-85A7-4524-B717-771D6CE97C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5467D-B0EC-45CD-B3A4-67C01CFFBA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E1F9E-5AD2-4DF6-9C6C-F61A4964B3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1539C3-9EA5-46DE-AD97-40B4A70C0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BD8F05-81A9-4FAC-98DE-1FE59B6F37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Te Pas et al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58512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dditional file 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Networks of Pathways and constructio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826920" y="1628640"/>
            <a:ext cx="7632720" cy="343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042920" y="1841400"/>
            <a:ext cx="7129440" cy="4330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7" name=""/>
          <p:cNvSpPr/>
          <p:nvPr/>
        </p:nvSpPr>
        <p:spPr>
          <a:xfrm>
            <a:off x="2610000" y="28004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onstruction of part of the network</a:t>
            </a:r>
            <a:br>
              <a:rPr sz="4000"/>
            </a:b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onnection between Focal adhesion and MAPK signaling pathway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250920" y="1989000"/>
            <a:ext cx="3128760" cy="2909880"/>
          </a:xfrm>
          <a:prstGeom prst="rect">
            <a:avLst/>
          </a:prstGeom>
          <a:ln w="9360">
            <a:solidFill>
              <a:srgbClr val="000000"/>
            </a:solidFill>
            <a:prstDash val="sysDot"/>
            <a:miter/>
          </a:ln>
        </p:spPr>
      </p:pic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3276720" y="4076640"/>
            <a:ext cx="4676760" cy="1914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1" name=""/>
          <p:cNvSpPr/>
          <p:nvPr/>
        </p:nvSpPr>
        <p:spPr>
          <a:xfrm>
            <a:off x="379800" y="1504800"/>
            <a:ext cx="172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cal adhe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546720" y="3449520"/>
            <a:ext cx="178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PK signal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68360" y="4149720"/>
            <a:ext cx="1224000" cy="144360"/>
          </a:xfrm>
          <a:prstGeom prst="leftRightArrow">
            <a:avLst>
              <a:gd name="adj1" fmla="val 50000"/>
              <a:gd name="adj2" fmla="val 168791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Focal adhesion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826920" y="1916280"/>
            <a:ext cx="6948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PK signaling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1835280" y="1916280"/>
            <a:ext cx="55339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09T13:02:32Z</dcterms:created>
  <dc:creator>Marinus te Pas</dc:creator>
  <dc:description/>
  <dc:language>en-US</dc:language>
  <cp:lastModifiedBy>Marinus te Pas</cp:lastModifiedBy>
  <dcterms:modified xsi:type="dcterms:W3CDTF">2006-11-09T14:37:56Z</dcterms:modified>
  <cp:revision>5</cp:revision>
  <dc:subject/>
  <dc:title>Dia 1</dc:title>
</cp:coreProperties>
</file>